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1152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4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4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4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6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533400" y="3505200"/>
            <a:ext cx="80772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: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sz="12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12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]Indole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, [</a:t>
            </a:r>
            <a:r>
              <a:rPr lang="en-US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12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]tryptophan, and [</a:t>
            </a:r>
            <a:r>
              <a:rPr lang="en-US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]anthranilate labeling of IAA precursors in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Arabidopsi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hypocotyls in the presence of YDF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eedlings were grown in the dark for 7 d, then transferred onto media with or without 10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YDF. Seedlings were then exposed to a 16 h photoperiod of red light (660 nm, 135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μmo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for 1 day, and then treated by applying a solution containing 10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[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]indole, 50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[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]tryptophan, and 50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[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]anthranilate for 16 hours under red light. Samples containing approximately 20 hypocotyls were collected for LC-MS analysis of isotopic enrichment of IAA and IAA biosynthesis intermediates. Data are expressed as the percentage of total detected compound containing the specified isotopic label. </a:t>
            </a: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4911577"/>
              </p:ext>
            </p:extLst>
          </p:nvPr>
        </p:nvGraphicFramePr>
        <p:xfrm>
          <a:off x="152400" y="457200"/>
          <a:ext cx="8832594" cy="297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3" name="SPW 12.0 Graph" r:id="rId3" imgW="19918574" imgH="6700913" progId="SigmaPlotGraphicObject.11">
                  <p:embed/>
                </p:oleObj>
              </mc:Choice>
              <mc:Fallback>
                <p:oleObj name="SPW 12.0 Graph" r:id="rId3" imgW="19918574" imgH="6700913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2400" y="457200"/>
                        <a:ext cx="8832594" cy="297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0902032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9</TotalTime>
  <Words>138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SPW 12.0 Graph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lly</dc:creator>
  <cp:lastModifiedBy>Molly</cp:lastModifiedBy>
  <cp:revision>4</cp:revision>
  <dcterms:created xsi:type="dcterms:W3CDTF">2006-08-16T00:00:00Z</dcterms:created>
  <dcterms:modified xsi:type="dcterms:W3CDTF">2021-06-04T16:26:19Z</dcterms:modified>
</cp:coreProperties>
</file>